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  <p:sldId id="266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1" d="100"/>
          <a:sy n="61" d="100"/>
        </p:scale>
        <p:origin x="812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6CE2B5-4FE4-9042-F87E-71A251EE845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EBD6B4A-CBC1-2ED6-F367-E649C5C55F6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FF3042-E9DF-78B2-952B-4A7E65851C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82C60-3A66-4EA4-870C-47F7B7C45DFF}" type="datetimeFigureOut">
              <a:rPr lang="en-US" smtClean="0"/>
              <a:t>08-Jul-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2EE741-BD87-5E97-6C25-FD80959FFC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32D846-3899-296F-3E9D-78FDAFE7E5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3AAB-7563-47FC-8231-C15A9133ED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21362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2D8700-0319-2E81-A833-E6216BFAF5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644BAEA-81CE-2EAB-FDA0-6160163951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594C5A-F77B-3724-B8A0-D0201E46C5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82C60-3A66-4EA4-870C-47F7B7C45DFF}" type="datetimeFigureOut">
              <a:rPr lang="en-US" smtClean="0"/>
              <a:t>08-Jul-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BBD121-CCA6-F98E-DA71-D5E97AA0D9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E3B084-1B5B-2F10-8B95-65EE0B6E57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3AAB-7563-47FC-8231-C15A9133ED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34797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81B6F44-F67E-CC36-39E7-26866B859F8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D6F8DC2-E51F-BA0B-3CAE-902C5E33092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831FF3-5983-32FC-2AEC-65A0903652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82C60-3A66-4EA4-870C-47F7B7C45DFF}" type="datetimeFigureOut">
              <a:rPr lang="en-US" smtClean="0"/>
              <a:t>08-Jul-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A7807B-3696-2AFD-0DB0-F30329F7C5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1CB17E-3BF4-40E1-553B-48E9506BB4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3AAB-7563-47FC-8231-C15A9133ED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57224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51DA86-7FE8-ECBB-567F-5BC338FCA6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424048C-FE6B-B896-5411-E01F5B1CD52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736689-F7B1-9885-BCBA-FE1C461932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82C60-3A66-4EA4-870C-47F7B7C45DFF}" type="datetimeFigureOut">
              <a:rPr lang="en-US" smtClean="0"/>
              <a:t>08-Jul-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506984-AA5F-92DB-946B-3F0BFFB452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A039C6-ECA1-4377-196B-1A820F4C69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3AAB-7563-47FC-8231-C15A9133ED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81847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85945A-43E3-7732-ED40-0055BB9371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8E3EDAD-4D40-C4F6-5286-48D189D55A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381D9B-EF36-B064-3722-8126EC92C8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82C60-3A66-4EA4-870C-47F7B7C45DFF}" type="datetimeFigureOut">
              <a:rPr lang="en-US" smtClean="0"/>
              <a:t>08-Jul-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788136-80E9-94AA-C486-E3B731672E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CBEDAE-E508-3769-226A-C0830FF34E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3AAB-7563-47FC-8231-C15A9133ED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5507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9A184E-F114-AD5E-6BBC-654591C3FA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20A897E-8131-A0A9-6826-7D9687EFAF1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DF744FA-B450-B6AD-E699-1617D4DDAB3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F11F773-A1C4-DCE0-B82D-1A702F57F4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82C60-3A66-4EA4-870C-47F7B7C45DFF}" type="datetimeFigureOut">
              <a:rPr lang="en-US" smtClean="0"/>
              <a:t>08-Jul-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E06D34F-5F34-B57C-B2B4-EB77F66E10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80B0A7D-50F7-F8E5-CC67-D130A064A3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3AAB-7563-47FC-8231-C15A9133ED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27401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F859C1-09B4-13C0-ED06-098130A853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C8AF9C8-B02E-8EE9-9FAF-920B68CC9F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B9A416B-3496-6212-39A2-E4FDD2E82D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F451520-58C1-F2A8-BD11-D208A81270F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785CE5E-2193-C2E9-95FF-DAB31643449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DE1D87D-4EC9-EAD7-DB6E-5B44BAEB50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82C60-3A66-4EA4-870C-47F7B7C45DFF}" type="datetimeFigureOut">
              <a:rPr lang="en-US" smtClean="0"/>
              <a:t>08-Jul-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107900F-B6EA-F743-F3C3-E8A436751D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63E9CF1-E815-1F5B-BE5C-3A03BAEFA4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3AAB-7563-47FC-8231-C15A9133ED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13667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506D07-D130-7E73-1E20-633BEEFDC5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0373751-49CE-94A2-6E11-E30C81F043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82C60-3A66-4EA4-870C-47F7B7C45DFF}" type="datetimeFigureOut">
              <a:rPr lang="en-US" smtClean="0"/>
              <a:t>08-Jul-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9243EF3-E375-A03F-DC08-84F43D3376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1634903-FC68-DA70-58D1-CDDD87FC94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3AAB-7563-47FC-8231-C15A9133ED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92739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E7727EC-DA2D-ABE5-EED4-B5DE4ACD76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82C60-3A66-4EA4-870C-47F7B7C45DFF}" type="datetimeFigureOut">
              <a:rPr lang="en-US" smtClean="0"/>
              <a:t>08-Jul-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7C2A881-C2B6-AB08-A38F-3CE0DA89BC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9A3B257-B190-C52C-36A8-14B20EDD2A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3AAB-7563-47FC-8231-C15A9133ED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22093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D2E08E-EB69-B397-10C0-F12E225DA5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B546FDA-024A-9931-BA0F-CF5CD4BA1E7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BD84437-C30D-98A7-7393-DBDD3F13B7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E91F0E6-0D77-F4F4-E8AC-B9F4297147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82C60-3A66-4EA4-870C-47F7B7C45DFF}" type="datetimeFigureOut">
              <a:rPr lang="en-US" smtClean="0"/>
              <a:t>08-Jul-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05C7183-75B5-BCAA-30F5-FE3267DA65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1090096-E64D-CC40-CFD8-D8A44614DF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3AAB-7563-47FC-8231-C15A9133ED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7812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2A831A-5D36-0DC1-98CF-0A6FC1B487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D998814-D1AB-B5AF-6053-D1FB82D4B4F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C8710DC-AA53-0082-010F-18BACAF63E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CFD9E80-3769-2947-553F-5305798BCF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82C60-3A66-4EA4-870C-47F7B7C45DFF}" type="datetimeFigureOut">
              <a:rPr lang="en-US" smtClean="0"/>
              <a:t>08-Jul-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A94B125-1258-6D5A-0DF0-102B84FE91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7294F76-DF7A-5006-74E6-3BB24AB85F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2C3AAB-7563-47FC-8231-C15A9133ED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13400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EF21D74-6630-6458-E74B-A403F50E2F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A1C0795-1CE2-5430-FF92-95978A1443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73F961-10C7-A6BC-99B4-0EF46D878E9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D82C60-3A66-4EA4-870C-47F7B7C45DFF}" type="datetimeFigureOut">
              <a:rPr lang="en-US" smtClean="0"/>
              <a:t>08-Jul-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0F5861-8924-36AC-1A9D-A05BB142CBF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B142FE-AFCB-7178-AC06-25062794136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2C3AAB-7563-47FC-8231-C15A9133ED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83892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BB4A70B1-E58F-DD40-A4A2-03494FD945EF}"/>
              </a:ext>
            </a:extLst>
          </p:cNvPr>
          <p:cNvSpPr/>
          <p:nvPr/>
        </p:nvSpPr>
        <p:spPr>
          <a:xfrm>
            <a:off x="185058" y="5935694"/>
            <a:ext cx="11630546" cy="50494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MY" sz="1200" b="1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S1: </a:t>
            </a:r>
            <a:r>
              <a:rPr lang="en-MY" sz="1200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equencing of sgRNA sequence in (a) gRNA expression vectors </a:t>
            </a:r>
            <a:r>
              <a:rPr lang="en-US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(</a:t>
            </a:r>
            <a:r>
              <a:rPr lang="en-MY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gRep1-TN, gRep2-TN, and gRep3-TN)</a:t>
            </a:r>
            <a:r>
              <a:rPr lang="en-MY" sz="1200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nd (b) gRNA entry vectors </a:t>
            </a:r>
            <a:r>
              <a:rPr lang="en-MY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(pGGA3-TN). Sequence highlighted indicates the sgRNA sequences.</a:t>
            </a:r>
            <a:endParaRPr lang="en-MY" sz="1200" dirty="0"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0310C9F2-16C5-9FE8-95E8-993D78D8CC45}"/>
              </a:ext>
            </a:extLst>
          </p:cNvPr>
          <p:cNvGrpSpPr/>
          <p:nvPr/>
        </p:nvGrpSpPr>
        <p:grpSpPr>
          <a:xfrm>
            <a:off x="185058" y="222300"/>
            <a:ext cx="11851352" cy="5209118"/>
            <a:chOff x="185057" y="222300"/>
            <a:chExt cx="12006943" cy="5209118"/>
          </a:xfrm>
        </p:grpSpPr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8CC58979-FDA4-2D44-B6E5-E6BED141DB97}"/>
                </a:ext>
              </a:extLst>
            </p:cNvPr>
            <p:cNvSpPr/>
            <p:nvPr/>
          </p:nvSpPr>
          <p:spPr>
            <a:xfrm>
              <a:off x="185057" y="591632"/>
              <a:ext cx="5725886" cy="483978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sz="1000" dirty="0"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&gt;</a:t>
              </a:r>
              <a:r>
                <a:rPr lang="en-US" sz="1200" dirty="0"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gRep1-TN</a:t>
              </a:r>
              <a:endParaRPr lang="en-MY" sz="11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endParaRPr>
            </a:p>
            <a:p>
              <a:pPr algn="just">
                <a:spcAft>
                  <a:spcPts val="1000"/>
                </a:spcAft>
              </a:pPr>
              <a:r>
                <a:rPr lang="en-US" sz="1050" dirty="0">
                  <a:latin typeface="Times New Roman" panose="02020603050405020304" pitchFamily="18" charset="0"/>
                  <a:ea typeface="SimSun" panose="02010600030101010101" pitchFamily="2" charset="-122"/>
                  <a:cs typeface="Times New Roman" panose="02020603050405020304" pitchFamily="18" charset="0"/>
                </a:rPr>
                <a:t>tGGTACCGAGCTCGGATCCACTAGTAACGGCCGCCAGTGTGCTGGAATTGCCCTTGGATCATGAACCAACGGCCTGGCTGTATTTGGTGGTTGTGTAGGGAGATGGGGAGAAGAAAAGCCCGATTCTCTTCGCTGTGATGGGCTGGATGCATGCGGGGGAGCGGGAGGCCCAAGTACGTGCACGGTGAGCGGCCCACAGGGCGAGTGTGAGCGCGAGAGGCGGGAGGAACAGTTTAGTACCACATTGCCCAGCTAACTCGAACGCGACCAACTTATAAACCCGCGCGCTGTCGCTTGTGTG</a:t>
              </a:r>
              <a:r>
                <a:rPr lang="en-MY" sz="1000" dirty="0"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ea typeface="SimSun" panose="02010600030101010101" pitchFamily="2" charset="-122"/>
                  <a:cs typeface="Times New Roman" panose="02020603050405020304" pitchFamily="18" charset="0"/>
                </a:rPr>
                <a:t>CGTTAATATTAACGGAGAGTTG</a:t>
              </a:r>
              <a:r>
                <a:rPr lang="en-US" sz="1050" dirty="0">
                  <a:latin typeface="Times New Roman" panose="02020603050405020304" pitchFamily="18" charset="0"/>
                  <a:ea typeface="SimSun" panose="02010600030101010101" pitchFamily="2" charset="-122"/>
                  <a:cs typeface="Times New Roman" panose="02020603050405020304" pitchFamily="18" charset="0"/>
                </a:rPr>
                <a:t>TTTTAGAGCTAGAAATAGCAAGTTAAAATAAGGCTAGTCCGTTATCAACTTGAAAAAGTGGCACCGAGTCGGTGCTTTTTTTGTCCCTTCGAAGGGCAATTCTGCAGATATCCATCACACTGGCGGCCGCTCGAGGTCGAgGGTATCGATAAGCTT</a:t>
              </a:r>
              <a:endParaRPr lang="en-MY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endParaRPr>
            </a:p>
            <a:p>
              <a:pPr algn="just"/>
              <a:r>
                <a:rPr lang="en-US" sz="1400" dirty="0"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&gt;gRep2-TN</a:t>
              </a:r>
              <a:endParaRPr lang="en-MY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endParaRPr>
            </a:p>
            <a:p>
              <a:pPr algn="just">
                <a:spcAft>
                  <a:spcPts val="1000"/>
                </a:spcAft>
              </a:pPr>
              <a:r>
                <a:rPr lang="en-US" sz="1050" dirty="0">
                  <a:latin typeface="Times New Roman" panose="02020603050405020304" pitchFamily="18" charset="0"/>
                  <a:ea typeface="SimSun" panose="02010600030101010101" pitchFamily="2" charset="-122"/>
                  <a:cs typeface="Times New Roman" panose="02020603050405020304" pitchFamily="18" charset="0"/>
                </a:rPr>
                <a:t>tGGTACCGAGCTCGGATCCACTAGTAACGGCCGCCAGTGTGCTGGAATTGCCCTTGGATCATGAACCAACGGCCTGGCTGTATTTGGTGGTTGTGTAGGGAGATGGGGAGAAGAAAAGCCCGATTCTCTTCGCTGTGATGGGCTGGATGCATGCGGGGGAGCGGGAGGCCCAAGTACGTGCACGGTGAGCGGCCCACAGGGCGAGTGTGAGCGCGAGAGGCGGGAGGAACAGTTTAGTACCACATTGCCCAGCTAACTCGAACGCGACCAACTTATAAACCCGCGCGCTGTCGCTTGTGTG</a:t>
              </a:r>
              <a:r>
                <a:rPr lang="en-MY" sz="1000" dirty="0"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ea typeface="SimSun" panose="02010600030101010101" pitchFamily="2" charset="-122"/>
                  <a:cs typeface="Times New Roman" panose="02020603050405020304" pitchFamily="18" charset="0"/>
                </a:rPr>
                <a:t>CCTCACACTTTCTTATCTTATG</a:t>
              </a:r>
              <a:r>
                <a:rPr lang="en-US" sz="1050" dirty="0">
                  <a:latin typeface="Times New Roman" panose="02020603050405020304" pitchFamily="18" charset="0"/>
                  <a:ea typeface="SimSun" panose="02010600030101010101" pitchFamily="2" charset="-122"/>
                  <a:cs typeface="Times New Roman" panose="02020603050405020304" pitchFamily="18" charset="0"/>
                </a:rPr>
                <a:t>TTTTAGAGCTAGAAATAGCAAGTTAAAATAAGGCTAGTCCGTTATCAACTTGAAAAAGTGGCACCGAGTCGGTGCTTTTTTTGTCCCTTCGAAGGGCAATTCTGCAGATATCCATCACACTGGCGGCCGCTCGAGGTCGAgGGTATCGATAAGCTT</a:t>
              </a:r>
              <a:endParaRPr lang="en-MY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endParaRPr>
            </a:p>
            <a:p>
              <a:pPr algn="just"/>
              <a:r>
                <a:rPr lang="en-US" sz="1200" dirty="0"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&gt;gRep3-TN</a:t>
              </a:r>
              <a:endParaRPr lang="en-MY" sz="11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endParaRPr>
            </a:p>
            <a:p>
              <a:pPr algn="just">
                <a:spcAft>
                  <a:spcPts val="1000"/>
                </a:spcAft>
              </a:pPr>
              <a:r>
                <a:rPr lang="en-US" sz="1050" dirty="0">
                  <a:latin typeface="Times New Roman" panose="02020603050405020304" pitchFamily="18" charset="0"/>
                  <a:ea typeface="SimSun" panose="02010600030101010101" pitchFamily="2" charset="-122"/>
                  <a:cs typeface="Times New Roman" panose="02020603050405020304" pitchFamily="18" charset="0"/>
                </a:rPr>
                <a:t>tGGTACCGAGCTCGGATCCACTAGTAACGGCCGCCAGTGTGCTGGAATTGCCCTTGGATCATGAACCAACGGCCTGGCTGTATTTGGTGGTTGTGTAGGGAGATGGGGAGAAGAAAAGCCCGATTCTCTTCGCTGTGATGGGCTGGATGCATGCGGGGGAGCGGGAGGCCCAAGTACGTGCACGGTGAGCGGCCCACAGGGCGAGTGTGAGCGCGAGAGGCGGGAGGAACAGTTTAGTACCACATTGCCCAGCTAACTCGAACGCGACCAACTTATAAACCCGCGCGCTGTCGCTTGTGTG</a:t>
              </a:r>
              <a:r>
                <a:rPr lang="en-MY" sz="1000" dirty="0">
                  <a:solidFill>
                    <a:srgbClr val="FF0000"/>
                  </a:solidFill>
                  <a:effectLst/>
                  <a:latin typeface="Times New Roman" panose="02020603050405020304" pitchFamily="18" charset="0"/>
                  <a:ea typeface="SimSun" panose="02010600030101010101" pitchFamily="2" charset="-122"/>
                  <a:cs typeface="Times New Roman" panose="02020603050405020304" pitchFamily="18" charset="0"/>
                </a:rPr>
                <a:t>GAGAAAAGAAACTTGGGAGTTG</a:t>
              </a:r>
              <a:r>
                <a:rPr lang="en-US" sz="1050" dirty="0">
                  <a:latin typeface="Times New Roman" panose="02020603050405020304" pitchFamily="18" charset="0"/>
                  <a:ea typeface="SimSun" panose="02010600030101010101" pitchFamily="2" charset="-122"/>
                  <a:cs typeface="Times New Roman" panose="02020603050405020304" pitchFamily="18" charset="0"/>
                </a:rPr>
                <a:t>TTTTAGAGCTAGAAATAGCAAGTTAAAATAAGGCTAGTCCGTTATCAACTTGAAAAAGTGGCACCGAGTCGGTGCTTTTTTTGTCCCTTCGAAGGGCAATTCTGCAGATATCCATCACACTGGCGGCCGCTCGAGGTCGAgGGTATCGATAAGCTT</a:t>
              </a:r>
              <a:endParaRPr lang="en-MY" sz="10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endParaRPr>
            </a:p>
          </p:txBody>
        </p:sp>
        <p:pic>
          <p:nvPicPr>
            <p:cNvPr id="6" name="Picture 5" descr="Timeline&#10;&#10;Description automatically generated">
              <a:extLst>
                <a:ext uri="{FF2B5EF4-FFF2-40B4-BE49-F238E27FC236}">
                  <a16:creationId xmlns:a16="http://schemas.microsoft.com/office/drawing/2014/main" id="{E0874ADB-004E-E646-BE32-6D549D8BA65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019519" y="1039165"/>
              <a:ext cx="6172481" cy="4178159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533452C7-6D33-B141-BA84-50C98F10F42E}"/>
                </a:ext>
              </a:extLst>
            </p:cNvPr>
            <p:cNvSpPr txBox="1"/>
            <p:nvPr/>
          </p:nvSpPr>
          <p:spPr>
            <a:xfrm>
              <a:off x="6019519" y="669833"/>
              <a:ext cx="86594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&gt;pGGA3-TN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26D4F39D-491E-6C70-7DC3-331A63D1EA46}"/>
                </a:ext>
              </a:extLst>
            </p:cNvPr>
            <p:cNvSpPr txBox="1"/>
            <p:nvPr/>
          </p:nvSpPr>
          <p:spPr>
            <a:xfrm>
              <a:off x="185057" y="222300"/>
              <a:ext cx="4502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)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DD01E2FD-3DCA-505A-93CF-8C3D5848C3A7}"/>
                </a:ext>
              </a:extLst>
            </p:cNvPr>
            <p:cNvSpPr txBox="1"/>
            <p:nvPr/>
          </p:nvSpPr>
          <p:spPr>
            <a:xfrm>
              <a:off x="5970863" y="222300"/>
              <a:ext cx="45021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2844885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239A5A0D-A0E8-E44B-B3F6-1BBE618F543B}"/>
              </a:ext>
            </a:extLst>
          </p:cNvPr>
          <p:cNvSpPr/>
          <p:nvPr/>
        </p:nvSpPr>
        <p:spPr>
          <a:xfrm>
            <a:off x="831511" y="5372033"/>
            <a:ext cx="10528978" cy="50494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MY" sz="1200" b="1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 S2: </a:t>
            </a:r>
            <a:r>
              <a:rPr lang="en-MY" sz="1200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e 405 bp sequence from the sequencing of </a:t>
            </a:r>
            <a:r>
              <a:rPr lang="en-US" sz="1200" dirty="0" err="1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RISPRi</a:t>
            </a:r>
            <a:r>
              <a:rPr lang="en-US" sz="1200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vector, </a:t>
            </a:r>
            <a:r>
              <a:rPr lang="en-US" sz="1200" dirty="0" err="1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CTN</a:t>
            </a:r>
            <a:r>
              <a:rPr lang="en-MY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quence from dCas9 plasmid highlighted in orange; Sequences of gRNA highlighted in blue; Sequences from plant expression vector highlighted in green.</a:t>
            </a:r>
            <a:endParaRPr lang="en-MY" sz="1200" dirty="0"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F0CF1271-7D2F-BB29-7011-2EF144644F47}"/>
              </a:ext>
            </a:extLst>
          </p:cNvPr>
          <p:cNvGrpSpPr/>
          <p:nvPr/>
        </p:nvGrpSpPr>
        <p:grpSpPr>
          <a:xfrm>
            <a:off x="2853079" y="517568"/>
            <a:ext cx="6290921" cy="4749340"/>
            <a:chOff x="2853079" y="517568"/>
            <a:chExt cx="6290921" cy="4749340"/>
          </a:xfrm>
        </p:grpSpPr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843F0011-F157-9B45-969B-2A0EF6986D98}"/>
                </a:ext>
              </a:extLst>
            </p:cNvPr>
            <p:cNvSpPr/>
            <p:nvPr/>
          </p:nvSpPr>
          <p:spPr>
            <a:xfrm>
              <a:off x="3048000" y="517568"/>
              <a:ext cx="6096000" cy="357598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 marL="306070" indent="-304800" algn="just">
                <a:lnSpc>
                  <a:spcPct val="115000"/>
                </a:lnSpc>
                <a:spcAft>
                  <a:spcPts val="1000"/>
                </a:spcAft>
              </a:pPr>
              <a:r>
                <a:rPr lang="en-US" sz="1600" dirty="0">
                  <a:effectLst/>
                  <a:latin typeface="Times New Roman" panose="02020603050405020304" pitchFamily="18" charset="0"/>
                  <a:ea typeface="SimSun" panose="02010600030101010101" pitchFamily="2" charset="-122"/>
                  <a:cs typeface="Times New Roman" panose="02020603050405020304" pitchFamily="18" charset="0"/>
                </a:rPr>
                <a:t>&gt;</a:t>
              </a:r>
              <a:r>
                <a:rPr lang="en-US" sz="1600" dirty="0" err="1">
                  <a:effectLst/>
                  <a:latin typeface="Times New Roman" panose="02020603050405020304" pitchFamily="18" charset="0"/>
                  <a:ea typeface="SimSun" panose="02010600030101010101" pitchFamily="2" charset="-122"/>
                  <a:cs typeface="Times New Roman" panose="02020603050405020304" pitchFamily="18" charset="0"/>
                </a:rPr>
                <a:t>pCTN</a:t>
              </a:r>
              <a:endParaRPr lang="en-MY" sz="1600" dirty="0">
                <a:effectLst/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endParaRPr>
            </a:p>
          </p:txBody>
        </p:sp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5283263D-E7F6-A942-AE2A-0A5087BBED9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853079" y="875166"/>
              <a:ext cx="6096000" cy="439174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0264433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4</Words>
  <Application>Microsoft Office PowerPoint</Application>
  <PresentationFormat>Widescreen</PresentationFormat>
  <Paragraphs>1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Palatino Linotype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oon Chin Tan</dc:creator>
  <cp:lastModifiedBy>Boon Chin Tan</cp:lastModifiedBy>
  <cp:revision>1</cp:revision>
  <dcterms:created xsi:type="dcterms:W3CDTF">2022-07-08T15:04:28Z</dcterms:created>
  <dcterms:modified xsi:type="dcterms:W3CDTF">2022-07-08T15:05:11Z</dcterms:modified>
</cp:coreProperties>
</file>